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582031-7752-44DA-830F-10EBB1027D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79AE6-6113-4142-9A12-59958335DF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0D966-8830-49C6-890C-888F82E847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B8D65-6B4E-48F6-A787-497D4C1DF9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08269-3BF3-43EF-9765-9DF5331565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D47316-F874-4104-BE81-312820C0C2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A6282-479E-4962-A935-3F0D689D5D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777523-ADDA-460B-866B-46871B2BB8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73DCEA-8C07-4A80-BC3F-E836B39117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600B8-CDD8-4D81-AD20-10C152DCEC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485AD4-1FCB-4A07-A7B1-E0EA678B66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47ED03-A20B-4243-AB8C-EC88B7EE51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4E20B4-AAE8-484B-A6C6-86900908B084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3962520" y="939960"/>
            <a:ext cx="2176200" cy="33526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676440" y="939960"/>
            <a:ext cx="2224080" cy="3362040"/>
          </a:xfrm>
          <a:prstGeom prst="rect">
            <a:avLst/>
          </a:prstGeom>
          <a:ln w="0">
            <a:noFill/>
          </a:ln>
        </p:spPr>
      </p:pic>
      <p:sp>
        <p:nvSpPr>
          <p:cNvPr id="43" name="TextBox 8"/>
          <p:cNvSpPr/>
          <p:nvPr/>
        </p:nvSpPr>
        <p:spPr>
          <a:xfrm>
            <a:off x="713880" y="939960"/>
            <a:ext cx="87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3989880" y="939960"/>
            <a:ext cx="80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ET1s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69720" y="14436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13040" y="9320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39760" y="51228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3"/>
          <a:stretch/>
        </p:blipFill>
        <p:spPr>
          <a:xfrm>
            <a:off x="755640" y="4572000"/>
            <a:ext cx="5346720" cy="377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2006640" y="1181160"/>
            <a:ext cx="2496960" cy="155268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369720" y="14436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"/>
          <p:cNvSpPr/>
          <p:nvPr/>
        </p:nvSpPr>
        <p:spPr>
          <a:xfrm>
            <a:off x="369720" y="14436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1"/>
          <a:srcRect l="0" t="18626" r="0" b="0"/>
          <a:stretch/>
        </p:blipFill>
        <p:spPr>
          <a:xfrm>
            <a:off x="1339920" y="2751120"/>
            <a:ext cx="4178160" cy="156060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1671120" y="231300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ho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053880" y="2295360"/>
            <a:ext cx="76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ho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6-23T12:37:13Z</dcterms:created>
  <dc:creator>David Murray</dc:creator>
  <dc:description/>
  <dc:language>en-US</dc:language>
  <cp:lastModifiedBy>GKJanakiram</cp:lastModifiedBy>
  <cp:lastPrinted>2008-08-26T08:42:07Z</cp:lastPrinted>
  <dcterms:modified xsi:type="dcterms:W3CDTF">2008-09-18T16:40:23Z</dcterms:modified>
  <cp:revision>41</cp:revision>
  <dc:subject/>
  <dc:title>PowerPoint Presentation</dc:title>
</cp:coreProperties>
</file>